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00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50" autoAdjust="0"/>
    <p:restoredTop sz="94660"/>
  </p:normalViewPr>
  <p:slideViewPr>
    <p:cSldViewPr snapToGrid="0" showGuides="1">
      <p:cViewPr>
        <p:scale>
          <a:sx n="66" d="100"/>
          <a:sy n="66" d="100"/>
        </p:scale>
        <p:origin x="1816" y="-56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0A580-6DBB-44F8-93AC-7B46C661ED89}" type="datetimeFigureOut">
              <a:rPr kumimoji="1" lang="ja-JP" altLang="en-US" smtClean="0"/>
              <a:t>2021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E5132-7092-437A-B74A-201D1277E6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5255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0A580-6DBB-44F8-93AC-7B46C661ED89}" type="datetimeFigureOut">
              <a:rPr kumimoji="1" lang="ja-JP" altLang="en-US" smtClean="0"/>
              <a:t>2021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E5132-7092-437A-B74A-201D1277E6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3225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0A580-6DBB-44F8-93AC-7B46C661ED89}" type="datetimeFigureOut">
              <a:rPr kumimoji="1" lang="ja-JP" altLang="en-US" smtClean="0"/>
              <a:t>2021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E5132-7092-437A-B74A-201D1277E6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529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0A580-6DBB-44F8-93AC-7B46C661ED89}" type="datetimeFigureOut">
              <a:rPr kumimoji="1" lang="ja-JP" altLang="en-US" smtClean="0"/>
              <a:t>2021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E5132-7092-437A-B74A-201D1277E6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767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0A580-6DBB-44F8-93AC-7B46C661ED89}" type="datetimeFigureOut">
              <a:rPr kumimoji="1" lang="ja-JP" altLang="en-US" smtClean="0"/>
              <a:t>2021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E5132-7092-437A-B74A-201D1277E6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63775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0A580-6DBB-44F8-93AC-7B46C661ED89}" type="datetimeFigureOut">
              <a:rPr kumimoji="1" lang="ja-JP" altLang="en-US" smtClean="0"/>
              <a:t>2021/10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E5132-7092-437A-B74A-201D1277E6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1452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0A580-6DBB-44F8-93AC-7B46C661ED89}" type="datetimeFigureOut">
              <a:rPr kumimoji="1" lang="ja-JP" altLang="en-US" smtClean="0"/>
              <a:t>2021/10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E5132-7092-437A-B74A-201D1277E6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9214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0A580-6DBB-44F8-93AC-7B46C661ED89}" type="datetimeFigureOut">
              <a:rPr kumimoji="1" lang="ja-JP" altLang="en-US" smtClean="0"/>
              <a:t>2021/10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E5132-7092-437A-B74A-201D1277E6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278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0A580-6DBB-44F8-93AC-7B46C661ED89}" type="datetimeFigureOut">
              <a:rPr kumimoji="1" lang="ja-JP" altLang="en-US" smtClean="0"/>
              <a:t>2021/10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E5132-7092-437A-B74A-201D1277E6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8397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0A580-6DBB-44F8-93AC-7B46C661ED89}" type="datetimeFigureOut">
              <a:rPr kumimoji="1" lang="ja-JP" altLang="en-US" smtClean="0"/>
              <a:t>2021/10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E5132-7092-437A-B74A-201D1277E6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10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0A580-6DBB-44F8-93AC-7B46C661ED89}" type="datetimeFigureOut">
              <a:rPr kumimoji="1" lang="ja-JP" altLang="en-US" smtClean="0"/>
              <a:t>2021/10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E5132-7092-437A-B74A-201D1277E6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6085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E0A580-6DBB-44F8-93AC-7B46C661ED89}" type="datetimeFigureOut">
              <a:rPr kumimoji="1" lang="ja-JP" altLang="en-US" smtClean="0"/>
              <a:t>2021/10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E5132-7092-437A-B74A-201D1277E6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8452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F39FC8F8-D768-4F4E-BCF5-8D207F01A2B8}"/>
              </a:ext>
            </a:extLst>
          </p:cNvPr>
          <p:cNvGrpSpPr/>
          <p:nvPr/>
        </p:nvGrpSpPr>
        <p:grpSpPr>
          <a:xfrm>
            <a:off x="338249" y="3044199"/>
            <a:ext cx="6181500" cy="3973297"/>
            <a:chOff x="338249" y="3044199"/>
            <a:chExt cx="6181500" cy="3973297"/>
          </a:xfrm>
        </p:grpSpPr>
        <p:pic>
          <p:nvPicPr>
            <p:cNvPr id="2" name="図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t="140" b="140"/>
            <a:stretch/>
          </p:blipFill>
          <p:spPr>
            <a:xfrm>
              <a:off x="501650" y="3348035"/>
              <a:ext cx="5899359" cy="3198815"/>
            </a:xfrm>
            <a:prstGeom prst="rect">
              <a:avLst/>
            </a:prstGeom>
          </p:spPr>
        </p:pic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5C0602C8-C0E5-496D-9073-3D025217673B}"/>
                </a:ext>
              </a:extLst>
            </p:cNvPr>
            <p:cNvGrpSpPr/>
            <p:nvPr/>
          </p:nvGrpSpPr>
          <p:grpSpPr>
            <a:xfrm>
              <a:off x="1329509" y="3564160"/>
              <a:ext cx="4696326" cy="620456"/>
              <a:chOff x="1158059" y="3557810"/>
              <a:chExt cx="4696326" cy="620456"/>
            </a:xfrm>
          </p:grpSpPr>
          <p:sp>
            <p:nvSpPr>
              <p:cNvPr id="4" name="テキスト ボックス 3"/>
              <p:cNvSpPr txBox="1"/>
              <p:nvPr/>
            </p:nvSpPr>
            <p:spPr>
              <a:xfrm>
                <a:off x="1158059" y="3778156"/>
                <a:ext cx="179247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depth of response</a:t>
                </a:r>
                <a:r>
                  <a:rPr lang="ja-JP" alt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： </a:t>
                </a:r>
                <a:r>
                  <a:rPr lang="en-US" altLang="ja-JP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1%</a:t>
                </a:r>
              </a:p>
              <a:p>
                <a:r>
                  <a:rPr lang="en-US" altLang="ja-JP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5% CI [-12% to -30%]</a:t>
                </a:r>
                <a:endParaRPr kumimoji="1" lang="ja-JP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>
                <a:off x="4061907" y="3778156"/>
                <a:ext cx="179247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 depth of response</a:t>
                </a:r>
                <a:r>
                  <a:rPr lang="ja-JP" alt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： </a:t>
                </a:r>
                <a:r>
                  <a:rPr lang="en-US" altLang="ja-JP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4%</a:t>
                </a:r>
              </a:p>
              <a:p>
                <a:r>
                  <a:rPr lang="en-US" altLang="ja-JP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5% CI [-3% to -25%]</a:t>
                </a:r>
                <a:endParaRPr kumimoji="1" lang="ja-JP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テキスト ボックス 41"/>
              <p:cNvSpPr txBox="1"/>
              <p:nvPr/>
            </p:nvSpPr>
            <p:spPr>
              <a:xfrm>
                <a:off x="1158059" y="3557810"/>
                <a:ext cx="1154141" cy="30324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ab-PTX+RAM</a:t>
                </a:r>
                <a:endParaRPr kumimoji="1" lang="ja-JP" altLang="en-US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テキスト ボックス 41"/>
              <p:cNvSpPr txBox="1"/>
              <p:nvPr/>
            </p:nvSpPr>
            <p:spPr>
              <a:xfrm>
                <a:off x="4061907" y="3557810"/>
                <a:ext cx="894140" cy="30324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TX+RAM</a:t>
                </a:r>
                <a:endParaRPr kumimoji="1" lang="ja-JP" altLang="en-US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" name="テキスト ボックス 10"/>
            <p:cNvSpPr txBox="1"/>
            <p:nvPr/>
          </p:nvSpPr>
          <p:spPr>
            <a:xfrm rot="10800000">
              <a:off x="388729" y="4024378"/>
              <a:ext cx="338554" cy="185724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ximum tumor shrinkage</a:t>
              </a:r>
              <a:r>
                <a:rPr kumimoji="1"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%)</a:t>
              </a:r>
              <a:endParaRPr kumimoji="1" lang="ja-JP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正方形/長方形 11"/>
            <p:cNvSpPr/>
            <p:nvPr/>
          </p:nvSpPr>
          <p:spPr>
            <a:xfrm>
              <a:off x="388728" y="3295650"/>
              <a:ext cx="6080543" cy="331992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C637BCD2-88FF-406A-AE40-F94A2E116326}"/>
                </a:ext>
              </a:extLst>
            </p:cNvPr>
            <p:cNvSpPr txBox="1"/>
            <p:nvPr/>
          </p:nvSpPr>
          <p:spPr>
            <a:xfrm>
              <a:off x="388728" y="3044199"/>
              <a:ext cx="19399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nline Resource</a:t>
              </a:r>
              <a:r>
                <a:rPr kumimoji="1" lang="en-US" altLang="ja-JP" sz="1000" b="1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kumimoji="1"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aterfall plot</a:t>
              </a: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7A27A57E-5760-4ABB-9BD0-5AEF22F0082A}"/>
                </a:ext>
              </a:extLst>
            </p:cNvPr>
            <p:cNvSpPr txBox="1"/>
            <p:nvPr/>
          </p:nvSpPr>
          <p:spPr>
            <a:xfrm>
              <a:off x="338249" y="6617386"/>
              <a:ext cx="61815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i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n</a:t>
              </a:r>
              <a:r>
                <a:rPr lang="en-US" altLang="ja-JP" sz="10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b-PTX+RAM</a:t>
              </a:r>
              <a:r>
                <a:rPr lang="en-US" altLang="ja-JP" sz="1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nanoparticle albumin-bound paclitaxel plus ramucirumab, </a:t>
              </a:r>
              <a:r>
                <a:rPr lang="en-US" altLang="ja-JP" sz="10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TX+RAM</a:t>
              </a:r>
              <a:r>
                <a:rPr lang="en-US" altLang="ja-JP" sz="1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paclitaxel plus ramucirumab, </a:t>
              </a:r>
            </a:p>
            <a:p>
              <a:r>
                <a:rPr lang="en-US" altLang="ja-JP" sz="10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CI</a:t>
              </a:r>
              <a:r>
                <a:rPr lang="en-US" altLang="ja-JP" sz="1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confidence interval.</a:t>
              </a:r>
              <a:endParaRPr kumimoji="1" lang="ja-JP" alt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38759479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8</TotalTime>
  <Words>71</Words>
  <Application>Microsoft Office PowerPoint</Application>
  <PresentationFormat>A4 210 x 297 mm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sya akio</dc:creator>
  <cp:lastModifiedBy>g0ldship@outlook.jp</cp:lastModifiedBy>
  <cp:revision>92</cp:revision>
  <dcterms:created xsi:type="dcterms:W3CDTF">2021-04-15T04:21:20Z</dcterms:created>
  <dcterms:modified xsi:type="dcterms:W3CDTF">2021-10-06T03:39:29Z</dcterms:modified>
</cp:coreProperties>
</file>